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4"/>
  </p:notesMasterIdLst>
  <p:sldIdLst>
    <p:sldId id="268" r:id="rId2"/>
    <p:sldId id="269" r:id="rId3"/>
  </p:sldIdLst>
  <p:sldSz cx="6858000" cy="9906000" type="A4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llanmörkt format 2 - Dekorfärg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343" autoAdjust="0"/>
    <p:restoredTop sz="94660"/>
  </p:normalViewPr>
  <p:slideViewPr>
    <p:cSldViewPr snapToGrid="0">
      <p:cViewPr varScale="1">
        <p:scale>
          <a:sx n="47" d="100"/>
          <a:sy n="47" d="100"/>
        </p:scale>
        <p:origin x="2488" y="6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sidhuvud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sv-SE"/>
          </a:p>
        </p:txBody>
      </p:sp>
      <p:sp>
        <p:nvSpPr>
          <p:cNvPr id="3" name="Platshållare för datum 2"/>
          <p:cNvSpPr>
            <a:spLocks noGrp="1"/>
          </p:cNvSpPr>
          <p:nvPr>
            <p:ph type="dt" idx="1"/>
          </p:nvPr>
        </p:nvSpPr>
        <p:spPr>
          <a:xfrm>
            <a:off x="5179484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F5B3F4D-34EA-4CBC-A6A9-1DCA507114A6}" type="datetimeFigureOut">
              <a:rPr lang="sv-SE" smtClean="0"/>
              <a:t>2023-05-12</a:t>
            </a:fld>
            <a:endParaRPr lang="sv-SE"/>
          </a:p>
        </p:txBody>
      </p:sp>
      <p:sp>
        <p:nvSpPr>
          <p:cNvPr id="4" name="Platshållare för bildobjekt 3"/>
          <p:cNvSpPr>
            <a:spLocks noGrp="1" noRot="1" noChangeAspect="1"/>
          </p:cNvSpPr>
          <p:nvPr>
            <p:ph type="sldImg" idx="2"/>
          </p:nvPr>
        </p:nvSpPr>
        <p:spPr>
          <a:xfrm>
            <a:off x="3770313" y="857250"/>
            <a:ext cx="1603375" cy="2314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sv-SE"/>
          </a:p>
        </p:txBody>
      </p:sp>
      <p:sp>
        <p:nvSpPr>
          <p:cNvPr id="5" name="Platshållare för anteckningar 4"/>
          <p:cNvSpPr>
            <a:spLocks noGrp="1"/>
          </p:cNvSpPr>
          <p:nvPr>
            <p:ph type="body" sz="quarter" idx="3"/>
          </p:nvPr>
        </p:nvSpPr>
        <p:spPr>
          <a:xfrm>
            <a:off x="914400" y="3300412"/>
            <a:ext cx="7315200" cy="2700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4"/>
          </p:nvPr>
        </p:nvSpPr>
        <p:spPr>
          <a:xfrm>
            <a:off x="0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5"/>
          </p:nvPr>
        </p:nvSpPr>
        <p:spPr>
          <a:xfrm>
            <a:off x="5179484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EAF2A93-344A-4D26-8454-433AD10F8453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19152524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72" indent="0" algn="ctr">
              <a:buNone/>
              <a:defRPr sz="1500"/>
            </a:lvl2pPr>
            <a:lvl3pPr marL="685743" indent="0" algn="ctr">
              <a:buNone/>
              <a:defRPr sz="1350"/>
            </a:lvl3pPr>
            <a:lvl4pPr marL="1028614" indent="0" algn="ctr">
              <a:buNone/>
              <a:defRPr sz="1200"/>
            </a:lvl4pPr>
            <a:lvl5pPr marL="1371486" indent="0" algn="ctr">
              <a:buNone/>
              <a:defRPr sz="1200"/>
            </a:lvl5pPr>
            <a:lvl6pPr marL="1714356" indent="0" algn="ctr">
              <a:buNone/>
              <a:defRPr sz="1200"/>
            </a:lvl6pPr>
            <a:lvl7pPr marL="2057228" indent="0" algn="ctr">
              <a:buNone/>
              <a:defRPr sz="1200"/>
            </a:lvl7pPr>
            <a:lvl8pPr marL="2400098" indent="0" algn="ctr">
              <a:buNone/>
              <a:defRPr sz="1200"/>
            </a:lvl8pPr>
            <a:lvl9pPr marL="274297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482FC-EFAF-4064-B181-B975EB2696C7}" type="datetimeFigureOut">
              <a:rPr lang="sv-SE" smtClean="0"/>
              <a:t>2023-05-12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2C9755-7CC8-4EDE-B263-34C0D0C0125C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1541154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482FC-EFAF-4064-B181-B975EB2696C7}" type="datetimeFigureOut">
              <a:rPr lang="sv-SE" smtClean="0"/>
              <a:t>2023-05-12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2C9755-7CC8-4EDE-B263-34C0D0C0125C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1140615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482FC-EFAF-4064-B181-B975EB2696C7}" type="datetimeFigureOut">
              <a:rPr lang="sv-SE" smtClean="0"/>
              <a:t>2023-05-12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2C9755-7CC8-4EDE-B263-34C0D0C0125C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9878049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482FC-EFAF-4064-B181-B975EB2696C7}" type="datetimeFigureOut">
              <a:rPr lang="sv-SE" smtClean="0"/>
              <a:t>2023-05-12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2C9755-7CC8-4EDE-B263-34C0D0C0125C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3292431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8" y="2469625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8" y="6629229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872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743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61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486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356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228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098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297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482FC-EFAF-4064-B181-B975EB2696C7}" type="datetimeFigureOut">
              <a:rPr lang="sv-SE" smtClean="0"/>
              <a:t>2023-05-12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2C9755-7CC8-4EDE-B263-34C0D0C0125C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2348738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482FC-EFAF-4064-B181-B975EB2696C7}" type="datetimeFigureOut">
              <a:rPr lang="sv-SE" smtClean="0"/>
              <a:t>2023-05-12</a:t>
            </a:fld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2C9755-7CC8-4EDE-B263-34C0D0C0125C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6131815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3" y="527406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428348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72" indent="0">
              <a:buNone/>
              <a:defRPr sz="1500" b="1"/>
            </a:lvl2pPr>
            <a:lvl3pPr marL="685743" indent="0">
              <a:buNone/>
              <a:defRPr sz="1350" b="1"/>
            </a:lvl3pPr>
            <a:lvl4pPr marL="1028614" indent="0">
              <a:buNone/>
              <a:defRPr sz="1200" b="1"/>
            </a:lvl4pPr>
            <a:lvl5pPr marL="1371486" indent="0">
              <a:buNone/>
              <a:defRPr sz="1200" b="1"/>
            </a:lvl5pPr>
            <a:lvl6pPr marL="1714356" indent="0">
              <a:buNone/>
              <a:defRPr sz="1200" b="1"/>
            </a:lvl6pPr>
            <a:lvl7pPr marL="2057228" indent="0">
              <a:buNone/>
              <a:defRPr sz="1200" b="1"/>
            </a:lvl7pPr>
            <a:lvl8pPr marL="2400098" indent="0">
              <a:buNone/>
              <a:defRPr sz="1200" b="1"/>
            </a:lvl8pPr>
            <a:lvl9pPr marL="274297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618443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428348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72" indent="0">
              <a:buNone/>
              <a:defRPr sz="1500" b="1"/>
            </a:lvl2pPr>
            <a:lvl3pPr marL="685743" indent="0">
              <a:buNone/>
              <a:defRPr sz="1350" b="1"/>
            </a:lvl3pPr>
            <a:lvl4pPr marL="1028614" indent="0">
              <a:buNone/>
              <a:defRPr sz="1200" b="1"/>
            </a:lvl4pPr>
            <a:lvl5pPr marL="1371486" indent="0">
              <a:buNone/>
              <a:defRPr sz="1200" b="1"/>
            </a:lvl5pPr>
            <a:lvl6pPr marL="1714356" indent="0">
              <a:buNone/>
              <a:defRPr sz="1200" b="1"/>
            </a:lvl6pPr>
            <a:lvl7pPr marL="2057228" indent="0">
              <a:buNone/>
              <a:defRPr sz="1200" b="1"/>
            </a:lvl7pPr>
            <a:lvl8pPr marL="2400098" indent="0">
              <a:buNone/>
              <a:defRPr sz="1200" b="1"/>
            </a:lvl8pPr>
            <a:lvl9pPr marL="274297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618443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482FC-EFAF-4064-B181-B975EB2696C7}" type="datetimeFigureOut">
              <a:rPr lang="sv-SE" smtClean="0"/>
              <a:t>2023-05-12</a:t>
            </a:fld>
            <a:endParaRPr lang="sv-S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2C9755-7CC8-4EDE-B263-34C0D0C0125C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8256177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482FC-EFAF-4064-B181-B975EB2696C7}" type="datetimeFigureOut">
              <a:rPr lang="sv-SE" smtClean="0"/>
              <a:t>2023-05-12</a:t>
            </a:fld>
            <a:endParaRPr lang="sv-S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2C9755-7CC8-4EDE-B263-34C0D0C0125C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1835636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482FC-EFAF-4064-B181-B975EB2696C7}" type="datetimeFigureOut">
              <a:rPr lang="sv-SE" smtClean="0"/>
              <a:t>2023-05-12</a:t>
            </a:fld>
            <a:endParaRPr lang="sv-S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2C9755-7CC8-4EDE-B263-34C0D0C0125C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4978427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5" y="1426285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72" indent="0">
              <a:buNone/>
              <a:defRPr sz="1050"/>
            </a:lvl2pPr>
            <a:lvl3pPr marL="685743" indent="0">
              <a:buNone/>
              <a:defRPr sz="900"/>
            </a:lvl3pPr>
            <a:lvl4pPr marL="1028614" indent="0">
              <a:buNone/>
              <a:defRPr sz="750"/>
            </a:lvl4pPr>
            <a:lvl5pPr marL="1371486" indent="0">
              <a:buNone/>
              <a:defRPr sz="750"/>
            </a:lvl5pPr>
            <a:lvl6pPr marL="1714356" indent="0">
              <a:buNone/>
              <a:defRPr sz="750"/>
            </a:lvl6pPr>
            <a:lvl7pPr marL="2057228" indent="0">
              <a:buNone/>
              <a:defRPr sz="750"/>
            </a:lvl7pPr>
            <a:lvl8pPr marL="2400098" indent="0">
              <a:buNone/>
              <a:defRPr sz="750"/>
            </a:lvl8pPr>
            <a:lvl9pPr marL="274297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482FC-EFAF-4064-B181-B975EB2696C7}" type="datetimeFigureOut">
              <a:rPr lang="sv-SE" smtClean="0"/>
              <a:t>2023-05-12</a:t>
            </a:fld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2C9755-7CC8-4EDE-B263-34C0D0C0125C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0165697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5" y="1426285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872" indent="0">
              <a:buNone/>
              <a:defRPr sz="2100"/>
            </a:lvl2pPr>
            <a:lvl3pPr marL="685743" indent="0">
              <a:buNone/>
              <a:defRPr sz="1800"/>
            </a:lvl3pPr>
            <a:lvl4pPr marL="1028614" indent="0">
              <a:buNone/>
              <a:defRPr sz="1500"/>
            </a:lvl4pPr>
            <a:lvl5pPr marL="1371486" indent="0">
              <a:buNone/>
              <a:defRPr sz="1500"/>
            </a:lvl5pPr>
            <a:lvl6pPr marL="1714356" indent="0">
              <a:buNone/>
              <a:defRPr sz="1500"/>
            </a:lvl6pPr>
            <a:lvl7pPr marL="2057228" indent="0">
              <a:buNone/>
              <a:defRPr sz="1500"/>
            </a:lvl7pPr>
            <a:lvl8pPr marL="2400098" indent="0">
              <a:buNone/>
              <a:defRPr sz="1500"/>
            </a:lvl8pPr>
            <a:lvl9pPr marL="274297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72" indent="0">
              <a:buNone/>
              <a:defRPr sz="1050"/>
            </a:lvl2pPr>
            <a:lvl3pPr marL="685743" indent="0">
              <a:buNone/>
              <a:defRPr sz="900"/>
            </a:lvl3pPr>
            <a:lvl4pPr marL="1028614" indent="0">
              <a:buNone/>
              <a:defRPr sz="750"/>
            </a:lvl4pPr>
            <a:lvl5pPr marL="1371486" indent="0">
              <a:buNone/>
              <a:defRPr sz="750"/>
            </a:lvl5pPr>
            <a:lvl6pPr marL="1714356" indent="0">
              <a:buNone/>
              <a:defRPr sz="750"/>
            </a:lvl6pPr>
            <a:lvl7pPr marL="2057228" indent="0">
              <a:buNone/>
              <a:defRPr sz="750"/>
            </a:lvl7pPr>
            <a:lvl8pPr marL="2400098" indent="0">
              <a:buNone/>
              <a:defRPr sz="750"/>
            </a:lvl8pPr>
            <a:lvl9pPr marL="274297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482FC-EFAF-4064-B181-B975EB2696C7}" type="datetimeFigureOut">
              <a:rPr lang="sv-SE" smtClean="0"/>
              <a:t>2023-05-12</a:t>
            </a:fld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2C9755-7CC8-4EDE-B263-34C0D0C0125C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9314177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90" y="527406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90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9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5482FC-EFAF-4064-B181-B975EB2696C7}" type="datetimeFigureOut">
              <a:rPr lang="sv-SE" smtClean="0"/>
              <a:t>2023-05-12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5" y="9181399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9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2C9755-7CC8-4EDE-B263-34C0D0C0125C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6989135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743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36" indent="-171436" algn="l" defTabSz="685743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06" indent="-171436" algn="l" defTabSz="68574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178" indent="-171436" algn="l" defTabSz="68574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049" indent="-171436" algn="l" defTabSz="68574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2921" indent="-171436" algn="l" defTabSz="68574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792" indent="-171436" algn="l" defTabSz="68574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664" indent="-171436" algn="l" defTabSz="68574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535" indent="-171436" algn="l" defTabSz="68574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406" indent="-171436" algn="l" defTabSz="68574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4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872" algn="l" defTabSz="68574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743" algn="l" defTabSz="68574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614" algn="l" defTabSz="68574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486" algn="l" defTabSz="68574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356" algn="l" defTabSz="68574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228" algn="l" defTabSz="68574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098" algn="l" defTabSz="68574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2970" algn="l" defTabSz="68574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19D107BE-14C0-573C-7F22-9F88ECCE185B}"/>
              </a:ext>
            </a:extLst>
          </p:cNvPr>
          <p:cNvSpPr txBox="1"/>
          <p:nvPr/>
        </p:nvSpPr>
        <p:spPr>
          <a:xfrm>
            <a:off x="143691" y="248195"/>
            <a:ext cx="6141606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1: Adjusted relative risks with 95% confidence intervals of a first cardiac arrhythmia event within 30 days after COVID-19 in matched cohort study and stratified according to disease severity 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(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on-hospitalized and hospitalized individuals). Vertical dashed line indicates RR of 1. PSVT: Paroxysmal supraventricular tachycardia. </a:t>
            </a:r>
            <a:endParaRPr lang="sv-SE" sz="1200" b="1" dirty="0"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sv-SE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7" name="Tabell 6">
            <a:extLst>
              <a:ext uri="{FF2B5EF4-FFF2-40B4-BE49-F238E27FC236}">
                <a16:creationId xmlns:a16="http://schemas.microsoft.com/office/drawing/2014/main" id="{4A674E8D-CA8F-5A10-A8E6-888FDAA4736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3692006"/>
              </p:ext>
            </p:extLst>
          </p:nvPr>
        </p:nvGraphicFramePr>
        <p:xfrm>
          <a:off x="256981" y="1580193"/>
          <a:ext cx="6028316" cy="3101213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318995">
                  <a:extLst>
                    <a:ext uri="{9D8B030D-6E8A-4147-A177-3AD203B41FA5}">
                      <a16:colId xmlns:a16="http://schemas.microsoft.com/office/drawing/2014/main" val="2967082776"/>
                    </a:ext>
                  </a:extLst>
                </a:gridCol>
                <a:gridCol w="4051029">
                  <a:extLst>
                    <a:ext uri="{9D8B030D-6E8A-4147-A177-3AD203B41FA5}">
                      <a16:colId xmlns:a16="http://schemas.microsoft.com/office/drawing/2014/main" val="832184120"/>
                    </a:ext>
                  </a:extLst>
                </a:gridCol>
                <a:gridCol w="658292">
                  <a:extLst>
                    <a:ext uri="{9D8B030D-6E8A-4147-A177-3AD203B41FA5}">
                      <a16:colId xmlns:a16="http://schemas.microsoft.com/office/drawing/2014/main" val="1372043252"/>
                    </a:ext>
                  </a:extLst>
                </a:gridCol>
              </a:tblGrid>
              <a:tr h="441325"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500"/>
                        </a:spcBef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utcomes</a:t>
                      </a:r>
                      <a:endParaRPr lang="sv-SE" sz="9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R="63500" algn="ctr">
                        <a:lnSpc>
                          <a:spcPct val="107000"/>
                        </a:lnSpc>
                        <a:spcBef>
                          <a:spcPts val="500"/>
                        </a:spcBef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isk Ratio (95% CI)</a:t>
                      </a:r>
                      <a:endParaRPr lang="sv-SE" sz="9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500"/>
                        </a:spcBef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-value</a:t>
                      </a:r>
                      <a:endParaRPr lang="sv-SE" sz="9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09944678"/>
                  </a:ext>
                </a:extLst>
              </a:tr>
              <a:tr h="789059">
                <a:tc rowSpan="3">
                  <a:txBody>
                    <a:bodyPr/>
                    <a:lstStyle/>
                    <a:p>
                      <a:pPr marR="63500" algn="l">
                        <a:lnSpc>
                          <a:spcPct val="107000"/>
                        </a:lnSpc>
                        <a:spcBef>
                          <a:spcPts val="500"/>
                        </a:spcBef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9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R="63500" algn="l">
                        <a:lnSpc>
                          <a:spcPct val="107000"/>
                        </a:lnSpc>
                        <a:spcBef>
                          <a:spcPts val="500"/>
                        </a:spcBef>
                      </a:pPr>
                      <a:r>
                        <a:rPr lang="en-US" sz="9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rial tachycardias</a:t>
                      </a:r>
                      <a:endParaRPr lang="sv-SE" sz="9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R="63500" algn="l">
                        <a:lnSpc>
                          <a:spcPct val="107000"/>
                        </a:lnSpc>
                        <a:spcBef>
                          <a:spcPts val="500"/>
                        </a:spcBef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 Non-hospitalised                                                                                                                  </a:t>
                      </a:r>
                      <a:endParaRPr lang="sv-SE" sz="9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63500" marR="63500" algn="l">
                        <a:lnSpc>
                          <a:spcPct val="107000"/>
                        </a:lnSpc>
                        <a:spcBef>
                          <a:spcPts val="500"/>
                        </a:spcBef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Hospitalised</a:t>
                      </a:r>
                      <a:endParaRPr lang="sv-SE" sz="9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R="63500" algn="l">
                        <a:lnSpc>
                          <a:spcPct val="107000"/>
                        </a:lnSpc>
                        <a:spcBef>
                          <a:spcPts val="500"/>
                        </a:spcBef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9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R="63500" algn="l">
                        <a:lnSpc>
                          <a:spcPct val="107000"/>
                        </a:lnSpc>
                        <a:spcBef>
                          <a:spcPts val="500"/>
                        </a:spcBef>
                      </a:pPr>
                      <a:r>
                        <a:rPr lang="en-US" sz="9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SVT</a:t>
                      </a:r>
                      <a:endParaRPr lang="sv-SE" sz="9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R="63500" algn="l">
                        <a:lnSpc>
                          <a:spcPct val="107000"/>
                        </a:lnSpc>
                        <a:spcBef>
                          <a:spcPts val="500"/>
                        </a:spcBef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 Non-hospitalised</a:t>
                      </a:r>
                      <a:endParaRPr lang="sv-SE" sz="9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63500" marR="63500" algn="l">
                        <a:lnSpc>
                          <a:spcPct val="107000"/>
                        </a:lnSpc>
                        <a:spcBef>
                          <a:spcPts val="500"/>
                        </a:spcBef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Hospitalised</a:t>
                      </a:r>
                      <a:endParaRPr lang="sv-SE" sz="9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R="63500" algn="l">
                        <a:lnSpc>
                          <a:spcPct val="107000"/>
                        </a:lnSpc>
                        <a:spcBef>
                          <a:spcPts val="500"/>
                        </a:spcBef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9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R="63500" algn="l">
                        <a:lnSpc>
                          <a:spcPct val="107000"/>
                        </a:lnSpc>
                        <a:spcBef>
                          <a:spcPts val="500"/>
                        </a:spcBef>
                      </a:pPr>
                      <a:r>
                        <a:rPr lang="en-US" sz="9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dy-arrhythmias</a:t>
                      </a:r>
                      <a:endParaRPr lang="sv-SE" sz="9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R="63500" algn="l">
                        <a:lnSpc>
                          <a:spcPct val="107000"/>
                        </a:lnSpc>
                        <a:spcBef>
                          <a:spcPts val="500"/>
                        </a:spcBef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 Non-hospitalised</a:t>
                      </a:r>
                      <a:endParaRPr lang="sv-SE" sz="9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63500" marR="63500" algn="l">
                        <a:lnSpc>
                          <a:spcPct val="107000"/>
                        </a:lnSpc>
                        <a:spcBef>
                          <a:spcPts val="500"/>
                        </a:spcBef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Hospitalised</a:t>
                      </a:r>
                      <a:endParaRPr lang="sv-SE" sz="9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500"/>
                        </a:spcBef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9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rowSpan="3">
                  <a:txBody>
                    <a:bodyPr/>
                    <a:lstStyle/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500"/>
                        </a:spcBef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9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500"/>
                        </a:spcBef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9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63500" marR="63500" algn="r">
                        <a:lnSpc>
                          <a:spcPct val="107000"/>
                        </a:lnSpc>
                        <a:spcBef>
                          <a:spcPts val="500"/>
                        </a:spcBef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9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500"/>
                        </a:spcBef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9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500"/>
                        </a:spcBef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9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500"/>
                        </a:spcBef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  <a:endParaRPr lang="sv-SE" sz="9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500"/>
                        </a:spcBef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  <a:endParaRPr lang="sv-SE" sz="9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5863460"/>
                  </a:ext>
                </a:extLst>
              </a:tr>
              <a:tr h="494030">
                <a:tc v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500"/>
                        </a:spcBef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9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500"/>
                        </a:spcBef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9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500"/>
                        </a:spcBef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  <a:endParaRPr lang="sv-SE" sz="9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500"/>
                        </a:spcBef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  <a:endParaRPr lang="sv-SE" sz="9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08153088"/>
                  </a:ext>
                </a:extLst>
              </a:tr>
              <a:tr h="417830">
                <a:tc v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500"/>
                        </a:spcBef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9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500"/>
                        </a:spcBef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9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500"/>
                        </a:spcBef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477</a:t>
                      </a:r>
                      <a:endParaRPr lang="sv-SE" sz="9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500"/>
                        </a:spcBef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  <a:endParaRPr lang="sv-SE" sz="9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86858291"/>
                  </a:ext>
                </a:extLst>
              </a:tr>
            </a:tbl>
          </a:graphicData>
        </a:graphic>
      </p:graphicFrame>
      <p:pic>
        <p:nvPicPr>
          <p:cNvPr id="11" name="Bildobjekt 10">
            <a:extLst>
              <a:ext uri="{FF2B5EF4-FFF2-40B4-BE49-F238E27FC236}">
                <a16:creationId xmlns:a16="http://schemas.microsoft.com/office/drawing/2014/main" id="{EC1B1AEA-3255-5F2F-2A17-666D08AAF798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405" b="4788"/>
          <a:stretch/>
        </p:blipFill>
        <p:spPr bwMode="auto">
          <a:xfrm>
            <a:off x="1788076" y="2310063"/>
            <a:ext cx="3602071" cy="2371343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</p:spTree>
    <p:extLst>
      <p:ext uri="{BB962C8B-B14F-4D97-AF65-F5344CB8AC3E}">
        <p14:creationId xmlns:p14="http://schemas.microsoft.com/office/powerpoint/2010/main" val="126078208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5C107160-5F09-B323-198E-7AE6056FF67B}"/>
              </a:ext>
            </a:extLst>
          </p:cNvPr>
          <p:cNvSpPr txBox="1"/>
          <p:nvPr/>
        </p:nvSpPr>
        <p:spPr>
          <a:xfrm>
            <a:off x="143691" y="248195"/>
            <a:ext cx="6045353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2: Adjusted relative risks with 95% confidence intervals of a first cardiac arrhythmia event within 30 days after COVID-19 in matched cohort study and stratified according to pandemic wave. Vertical dashed line indicates RR of 1. PSVT: Paroxysmal supraventricular tachycardia. </a:t>
            </a:r>
            <a:endParaRPr lang="sv-SE" sz="1200" b="1" dirty="0"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sv-SE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4" name="Tabell 3">
            <a:extLst>
              <a:ext uri="{FF2B5EF4-FFF2-40B4-BE49-F238E27FC236}">
                <a16:creationId xmlns:a16="http://schemas.microsoft.com/office/drawing/2014/main" id="{EF999DC0-C6D2-6082-19EF-4DE106F5390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85676414"/>
              </p:ext>
            </p:extLst>
          </p:nvPr>
        </p:nvGraphicFramePr>
        <p:xfrm>
          <a:off x="384860" y="1486032"/>
          <a:ext cx="5915025" cy="3521329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294207">
                  <a:extLst>
                    <a:ext uri="{9D8B030D-6E8A-4147-A177-3AD203B41FA5}">
                      <a16:colId xmlns:a16="http://schemas.microsoft.com/office/drawing/2014/main" val="1255038491"/>
                    </a:ext>
                  </a:extLst>
                </a:gridCol>
                <a:gridCol w="3974897">
                  <a:extLst>
                    <a:ext uri="{9D8B030D-6E8A-4147-A177-3AD203B41FA5}">
                      <a16:colId xmlns:a16="http://schemas.microsoft.com/office/drawing/2014/main" val="2761904661"/>
                    </a:ext>
                  </a:extLst>
                </a:gridCol>
                <a:gridCol w="645921">
                  <a:extLst>
                    <a:ext uri="{9D8B030D-6E8A-4147-A177-3AD203B41FA5}">
                      <a16:colId xmlns:a16="http://schemas.microsoft.com/office/drawing/2014/main" val="1729147669"/>
                    </a:ext>
                  </a:extLst>
                </a:gridCol>
              </a:tblGrid>
              <a:tr h="441325"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500"/>
                        </a:spcBef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utcomes</a:t>
                      </a:r>
                      <a:endParaRPr lang="sv-SE" sz="8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R="63500" algn="ctr">
                        <a:lnSpc>
                          <a:spcPct val="107000"/>
                        </a:lnSpc>
                        <a:spcBef>
                          <a:spcPts val="500"/>
                        </a:spcBef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isk Ratio (95% CI)</a:t>
                      </a:r>
                      <a:endParaRPr lang="sv-SE" sz="8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500"/>
                        </a:spcBef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-value</a:t>
                      </a:r>
                      <a:endParaRPr lang="sv-SE" sz="8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69958059"/>
                  </a:ext>
                </a:extLst>
              </a:tr>
              <a:tr h="619760">
                <a:tc rowSpan="3">
                  <a:txBody>
                    <a:bodyPr/>
                    <a:lstStyle/>
                    <a:p>
                      <a:pPr marR="63500" algn="l">
                        <a:lnSpc>
                          <a:spcPct val="107000"/>
                        </a:lnSpc>
                        <a:spcBef>
                          <a:spcPts val="500"/>
                        </a:spcBef>
                      </a:pP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R="63500" algn="l">
                        <a:lnSpc>
                          <a:spcPct val="107000"/>
                        </a:lnSpc>
                        <a:spcBef>
                          <a:spcPts val="500"/>
                        </a:spcBef>
                      </a:pPr>
                      <a:r>
                        <a:rPr lang="en-US" sz="8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rial tachycardias</a:t>
                      </a:r>
                      <a:endParaRPr lang="sv-SE" sz="8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R="63500" algn="l">
                        <a:lnSpc>
                          <a:spcPct val="107000"/>
                        </a:lnSpc>
                        <a:spcBef>
                          <a:spcPts val="500"/>
                        </a:spcBef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 First wave</a:t>
                      </a:r>
                      <a:endParaRPr lang="sv-SE" sz="8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R="63500" algn="l">
                        <a:lnSpc>
                          <a:spcPct val="107000"/>
                        </a:lnSpc>
                        <a:spcBef>
                          <a:spcPts val="500"/>
                        </a:spcBef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 Second wave</a:t>
                      </a:r>
                      <a:endParaRPr lang="sv-SE" sz="8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63500" marR="63500" algn="l">
                        <a:lnSpc>
                          <a:spcPct val="107000"/>
                        </a:lnSpc>
                        <a:spcBef>
                          <a:spcPts val="500"/>
                        </a:spcBef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Third wave</a:t>
                      </a:r>
                      <a:endParaRPr lang="sv-SE" sz="8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R="63500" algn="l">
                        <a:lnSpc>
                          <a:spcPct val="107000"/>
                        </a:lnSpc>
                        <a:spcBef>
                          <a:spcPts val="500"/>
                        </a:spcBef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8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R="63500" algn="l">
                        <a:lnSpc>
                          <a:spcPct val="107000"/>
                        </a:lnSpc>
                        <a:spcBef>
                          <a:spcPts val="500"/>
                        </a:spcBef>
                      </a:pPr>
                      <a:r>
                        <a:rPr lang="en-US" sz="8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SVT</a:t>
                      </a:r>
                      <a:endParaRPr lang="sv-SE" sz="8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R="63500" algn="l">
                        <a:lnSpc>
                          <a:spcPct val="107000"/>
                        </a:lnSpc>
                        <a:spcBef>
                          <a:spcPts val="500"/>
                        </a:spcBef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  First wave</a:t>
                      </a:r>
                      <a:endParaRPr lang="sv-SE" sz="8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R="63500" algn="l">
                        <a:lnSpc>
                          <a:spcPct val="107000"/>
                        </a:lnSpc>
                        <a:spcBef>
                          <a:spcPts val="500"/>
                        </a:spcBef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 Second wave</a:t>
                      </a:r>
                      <a:endParaRPr lang="sv-SE" sz="8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63500" marR="63500" algn="l">
                        <a:lnSpc>
                          <a:spcPct val="107000"/>
                        </a:lnSpc>
                        <a:spcBef>
                          <a:spcPts val="500"/>
                        </a:spcBef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Third wave</a:t>
                      </a:r>
                      <a:endParaRPr lang="sv-SE" sz="8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R="63500" algn="l">
                        <a:lnSpc>
                          <a:spcPct val="107000"/>
                        </a:lnSpc>
                        <a:spcBef>
                          <a:spcPts val="500"/>
                        </a:spcBef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8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R="63500" algn="l">
                        <a:lnSpc>
                          <a:spcPct val="107000"/>
                        </a:lnSpc>
                        <a:spcBef>
                          <a:spcPts val="500"/>
                        </a:spcBef>
                      </a:pPr>
                      <a:r>
                        <a:rPr lang="en-US" sz="8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dy-arrhythmias</a:t>
                      </a:r>
                      <a:endParaRPr lang="sv-SE" sz="8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R="63500" algn="l">
                        <a:lnSpc>
                          <a:spcPct val="107000"/>
                        </a:lnSpc>
                        <a:spcBef>
                          <a:spcPts val="500"/>
                        </a:spcBef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 First wave</a:t>
                      </a:r>
                      <a:endParaRPr lang="sv-SE" sz="8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R="63500" algn="l">
                        <a:lnSpc>
                          <a:spcPct val="107000"/>
                        </a:lnSpc>
                        <a:spcBef>
                          <a:spcPts val="500"/>
                        </a:spcBef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 Second wave</a:t>
                      </a:r>
                      <a:endParaRPr lang="sv-SE" sz="8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63500" marR="63500" algn="l">
                        <a:lnSpc>
                          <a:spcPct val="107000"/>
                        </a:lnSpc>
                        <a:spcBef>
                          <a:spcPts val="500"/>
                        </a:spcBef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Third wave</a:t>
                      </a:r>
                      <a:endParaRPr lang="sv-SE" sz="8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500"/>
                        </a:spcBef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8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rowSpan="3">
                  <a:txBody>
                    <a:bodyPr/>
                    <a:lstStyle/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500"/>
                        </a:spcBef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8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500"/>
                        </a:spcBef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8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63500" marR="63500" algn="r">
                        <a:lnSpc>
                          <a:spcPct val="107000"/>
                        </a:lnSpc>
                        <a:spcBef>
                          <a:spcPts val="500"/>
                        </a:spcBef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8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500"/>
                        </a:spcBef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8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500"/>
                        </a:spcBef>
                      </a:pP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500"/>
                        </a:spcBef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  <a:endParaRPr lang="sv-SE" sz="8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500"/>
                        </a:spcBef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  <a:endParaRPr lang="sv-SE" sz="8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500"/>
                        </a:spcBef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  <a:endParaRPr lang="sv-SE" sz="8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77789532"/>
                  </a:ext>
                </a:extLst>
              </a:tr>
              <a:tr h="494030">
                <a:tc v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500"/>
                        </a:spcBef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8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500"/>
                        </a:spcBef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8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500"/>
                        </a:spcBef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69</a:t>
                      </a:r>
                      <a:endParaRPr lang="sv-SE" sz="8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500"/>
                        </a:spcBef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  <a:endParaRPr lang="sv-SE" sz="8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500"/>
                        </a:spcBef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  <a:endParaRPr lang="sv-SE" sz="8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500"/>
                        </a:spcBef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8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500"/>
                        </a:spcBef>
                      </a:pP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500"/>
                        </a:spcBef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8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99977616"/>
                  </a:ext>
                </a:extLst>
              </a:tr>
              <a:tr h="417830">
                <a:tc v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500"/>
                        </a:spcBef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24</a:t>
                      </a:r>
                      <a:endParaRPr lang="sv-SE" sz="8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500"/>
                        </a:spcBef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  <a:endParaRPr lang="sv-SE" sz="8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500"/>
                        </a:spcBef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  <a:endParaRPr lang="sv-SE" sz="8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500"/>
                        </a:spcBef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8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84342094"/>
                  </a:ext>
                </a:extLst>
              </a:tr>
            </a:tbl>
          </a:graphicData>
        </a:graphic>
      </p:graphicFrame>
      <p:pic>
        <p:nvPicPr>
          <p:cNvPr id="5" name="Bildobjekt 4" descr="En bild som visar text, skärmbild, skärm, Rektangel&#10;&#10;Automatiskt genererad beskrivning">
            <a:extLst>
              <a:ext uri="{FF2B5EF4-FFF2-40B4-BE49-F238E27FC236}">
                <a16:creationId xmlns:a16="http://schemas.microsoft.com/office/drawing/2014/main" id="{E28FBB9A-9756-63BB-44F5-7C099DEAC527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817" b="3854"/>
          <a:stretch/>
        </p:blipFill>
        <p:spPr bwMode="auto">
          <a:xfrm>
            <a:off x="1434164" y="1991486"/>
            <a:ext cx="4235116" cy="3100278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</p:spTree>
    <p:extLst>
      <p:ext uri="{BB962C8B-B14F-4D97-AF65-F5344CB8AC3E}">
        <p14:creationId xmlns:p14="http://schemas.microsoft.com/office/powerpoint/2010/main" val="2136853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262</TotalTime>
  <Words>218</Words>
  <Application>Microsoft Office PowerPoint</Application>
  <PresentationFormat>A4 (210 x 297 mm)</PresentationFormat>
  <Paragraphs>72</Paragraphs>
  <Slides>2</Slides>
  <Notes>0</Notes>
  <HiddenSlides>0</HiddenSlides>
  <MMClips>0</MMClips>
  <ScaleCrop>false</ScaleCrop>
  <HeadingPairs>
    <vt:vector size="6" baseType="variant">
      <vt:variant>
        <vt:lpstr>Använt teckensnitt</vt:lpstr>
      </vt:variant>
      <vt:variant>
        <vt:i4>4</vt:i4>
      </vt:variant>
      <vt:variant>
        <vt:lpstr>Tema</vt:lpstr>
      </vt:variant>
      <vt:variant>
        <vt:i4>1</vt:i4>
      </vt:variant>
      <vt:variant>
        <vt:lpstr>Bildrubriker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-presentation</vt:lpstr>
      <vt:lpstr>PowerPoint-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ne-Marie Fors Connolly</dc:creator>
  <cp:lastModifiedBy>Ioannis Katsoularis</cp:lastModifiedBy>
  <cp:revision>21</cp:revision>
  <dcterms:created xsi:type="dcterms:W3CDTF">2021-10-21T14:32:35Z</dcterms:created>
  <dcterms:modified xsi:type="dcterms:W3CDTF">2023-05-12T12:47:13Z</dcterms:modified>
</cp:coreProperties>
</file>